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AEEA2-1E4B-4370-8971-FE971D4410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62BC9B-B97C-4B39-AD9E-50BC40F94B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6D1FB-6243-41AA-8A84-C78B8DD65C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C6C0F-8A2C-477F-BD73-E914835B9B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FD9428-9179-4C0E-B921-D0E1C763E1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1840F-8F2C-467F-858C-F696D953DC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89388-3287-4552-9F4C-4BFAF3E026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4D25C-CAF7-45A5-A0E0-B11BA98A21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282EB8-FC3B-4E90-AC36-51A15E82E9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A3B4E-E040-4C6D-9738-63C2DEEE19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603DE-4F18-4261-B161-53C3F8558C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C15EE-421F-429A-BFB2-D499E3B83F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B94F0B-5FE1-4C60-8B02-31A5F8CAC7E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D:\PAPER2\SNP\jsnp-haplotype\SNPmapping\draw\koshi.png"/>
          <p:cNvPicPr/>
          <p:nvPr/>
        </p:nvPicPr>
        <p:blipFill>
          <a:blip r:embed="rId1"/>
          <a:stretch/>
        </p:blipFill>
        <p:spPr>
          <a:xfrm>
            <a:off x="233280" y="692280"/>
            <a:ext cx="2898720" cy="2743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D:\PAPER2\SNP\jsnp-haplotype\SNPmapping\draw\eiko.png"/>
          <p:cNvPicPr/>
          <p:nvPr/>
        </p:nvPicPr>
        <p:blipFill>
          <a:blip r:embed="rId2"/>
          <a:stretch/>
        </p:blipFill>
        <p:spPr>
          <a:xfrm>
            <a:off x="3112920" y="692280"/>
            <a:ext cx="2899080" cy="2743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D:\PAPER2\SNP\jsnp-haplotype\SNPmapping\draw\rikuu132.png"/>
          <p:cNvPicPr/>
          <p:nvPr/>
        </p:nvPicPr>
        <p:blipFill>
          <a:blip r:embed="rId3"/>
          <a:stretch/>
        </p:blipFill>
        <p:spPr>
          <a:xfrm>
            <a:off x="5921280" y="692280"/>
            <a:ext cx="2898720" cy="2743200"/>
          </a:xfrm>
          <a:prstGeom prst="rect">
            <a:avLst/>
          </a:prstGeom>
          <a:ln w="0">
            <a:noFill/>
          </a:ln>
        </p:spPr>
      </p:pic>
      <p:sp>
        <p:nvSpPr>
          <p:cNvPr id="44" name="テキスト ボックス 6"/>
          <p:cNvSpPr/>
          <p:nvPr/>
        </p:nvSpPr>
        <p:spPr>
          <a:xfrm>
            <a:off x="684360" y="3284640"/>
            <a:ext cx="2303280" cy="143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093 SNP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NIAS_Os_aa0100000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IAS_Os_aa1200709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detected by comparing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between Koshihikari and Nipponbare sequence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7"/>
          <p:cNvSpPr/>
          <p:nvPr/>
        </p:nvSpPr>
        <p:spPr>
          <a:xfrm>
            <a:off x="3635280" y="3284640"/>
            <a:ext cx="2305080" cy="164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493 SNP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NIAS_Os_ab010000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IAS_Os_ab1200096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Detected by comparing betwee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Eiko and Nipponbare sequence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8"/>
          <p:cNvSpPr/>
          <p:nvPr/>
        </p:nvSpPr>
        <p:spPr>
          <a:xfrm>
            <a:off x="6443640" y="3284640"/>
            <a:ext cx="2305080" cy="143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673 SNP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NIAS_Os_ac010000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IAS_Os_ac1200082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detected by comparing between Rikuu132 and Nipponbare sequenc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11"/>
          <p:cNvSpPr/>
          <p:nvPr/>
        </p:nvSpPr>
        <p:spPr>
          <a:xfrm>
            <a:off x="244800" y="654120"/>
            <a:ext cx="78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12"/>
          <p:cNvSpPr/>
          <p:nvPr/>
        </p:nvSpPr>
        <p:spPr>
          <a:xfrm>
            <a:off x="198720" y="1171440"/>
            <a:ext cx="156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13"/>
          <p:cNvSpPr/>
          <p:nvPr/>
        </p:nvSpPr>
        <p:spPr>
          <a:xfrm>
            <a:off x="198720" y="1679400"/>
            <a:ext cx="156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4"/>
          <p:cNvSpPr/>
          <p:nvPr/>
        </p:nvSpPr>
        <p:spPr>
          <a:xfrm>
            <a:off x="198720" y="2198520"/>
            <a:ext cx="156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5"/>
          <p:cNvSpPr/>
          <p:nvPr/>
        </p:nvSpPr>
        <p:spPr>
          <a:xfrm>
            <a:off x="198720" y="2720880"/>
            <a:ext cx="156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16"/>
          <p:cNvSpPr/>
          <p:nvPr/>
        </p:nvSpPr>
        <p:spPr>
          <a:xfrm>
            <a:off x="198720" y="3240000"/>
            <a:ext cx="156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7"/>
          <p:cNvSpPr/>
          <p:nvPr/>
        </p:nvSpPr>
        <p:spPr>
          <a:xfrm>
            <a:off x="73440" y="420840"/>
            <a:ext cx="426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5"/>
          <p:cNvSpPr/>
          <p:nvPr/>
        </p:nvSpPr>
        <p:spPr>
          <a:xfrm>
            <a:off x="544680" y="5150160"/>
            <a:ext cx="7746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igure S1 Chromosomal distribution of SNPs used in our analysis of the genome structure of the Japanese rice population.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Vertical rectangles represent chromosomes 1 to 12 (from left to right) and colored horizontal bars indicate the locations of SNPs. Red arrowheads indicate the position of the centromere in each chromosom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6T01:30:24Z</dcterms:created>
  <dc:creator>yonemaru</dc:creator>
  <dc:description/>
  <dc:language>en-US</dc:language>
  <cp:lastModifiedBy>yonemaru</cp:lastModifiedBy>
  <dcterms:modified xsi:type="dcterms:W3CDTF">2011-11-19T18:55:37Z</dcterms:modified>
  <cp:revision>8</cp:revision>
  <dc:subject/>
  <dc:title>スライド 1</dc:title>
</cp:coreProperties>
</file>